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869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95551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emf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961C23-0827-3E4F-AA80-E799F157D78D}"/>
              </a:ext>
            </a:extLst>
          </p:cNvPr>
          <p:cNvSpPr txBox="1">
            <a:spLocks/>
          </p:cNvSpPr>
          <p:nvPr/>
        </p:nvSpPr>
        <p:spPr>
          <a:xfrm>
            <a:off x="0" y="4216"/>
            <a:ext cx="7692571" cy="376845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193BDFD-66A3-204C-9C18-F1E24354FD8C}"/>
              </a:ext>
            </a:extLst>
          </p:cNvPr>
          <p:cNvSpPr txBox="1"/>
          <p:nvPr/>
        </p:nvSpPr>
        <p:spPr>
          <a:xfrm>
            <a:off x="626229" y="388502"/>
            <a:ext cx="856607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CD4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947F9FB-3B7A-D140-BB72-AA2B9B980CF4}"/>
              </a:ext>
            </a:extLst>
          </p:cNvPr>
          <p:cNvSpPr txBox="1"/>
          <p:nvPr/>
        </p:nvSpPr>
        <p:spPr>
          <a:xfrm>
            <a:off x="306160" y="1985503"/>
            <a:ext cx="1421855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Perforin</a:t>
            </a:r>
            <a:endParaRPr lang="en-US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B0F28A9-7B91-FA4E-B4D5-BF50DB5FAA96}"/>
              </a:ext>
            </a:extLst>
          </p:cNvPr>
          <p:cNvSpPr txBox="1"/>
          <p:nvPr/>
        </p:nvSpPr>
        <p:spPr>
          <a:xfrm>
            <a:off x="2174805" y="1932581"/>
            <a:ext cx="1421855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IFN-</a:t>
            </a:r>
            <a:r>
              <a:rPr lang="en-US" sz="1000" b="1" dirty="0"/>
              <a:t>γ</a:t>
            </a:r>
            <a:endParaRPr lang="en-US" sz="1000" dirty="0"/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9BF5514B-E6D0-6E40-8A53-95D64C73835A}"/>
              </a:ext>
            </a:extLst>
          </p:cNvPr>
          <p:cNvSpPr txBox="1"/>
          <p:nvPr/>
        </p:nvSpPr>
        <p:spPr>
          <a:xfrm>
            <a:off x="274545" y="3486299"/>
            <a:ext cx="1639753" cy="244460"/>
          </a:xfrm>
          <a:prstGeom prst="rect">
            <a:avLst/>
          </a:prstGeom>
          <a:noFill/>
        </p:spPr>
        <p:txBody>
          <a:bodyPr wrap="square" lIns="89696" tIns="44848" rIns="89696" bIns="44848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>
                <a:ea typeface="Calibri"/>
                <a:cs typeface="Calibri"/>
              </a:rPr>
              <a:t>TNF-</a:t>
            </a:r>
            <a:r>
              <a:rPr lang="en-US" sz="1000" b="1" dirty="0">
                <a:ea typeface="+mn-lt"/>
                <a:cs typeface="+mn-lt"/>
              </a:rPr>
              <a:t>α</a:t>
            </a:r>
            <a:endParaRPr lang="en-US" sz="1000" b="1" i="1" u="sng" dirty="0">
              <a:ea typeface="+mn-lt"/>
              <a:cs typeface="+mn-lt"/>
            </a:endParaRPr>
          </a:p>
        </p:txBody>
      </p:sp>
      <p:sp>
        <p:nvSpPr>
          <p:cNvPr id="9" name="TextBox 33">
            <a:extLst>
              <a:ext uri="{FF2B5EF4-FFF2-40B4-BE49-F238E27FC236}">
                <a16:creationId xmlns:a16="http://schemas.microsoft.com/office/drawing/2014/main" id="{7811450D-8C44-FF42-AB48-A725A3EF56D4}"/>
              </a:ext>
            </a:extLst>
          </p:cNvPr>
          <p:cNvSpPr txBox="1"/>
          <p:nvPr/>
        </p:nvSpPr>
        <p:spPr>
          <a:xfrm>
            <a:off x="3961824" y="1904518"/>
            <a:ext cx="1421855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Granzyme A</a:t>
            </a:r>
            <a:endParaRPr lang="en-US" sz="1000" b="1" i="1" u="sng" dirty="0" err="1"/>
          </a:p>
        </p:txBody>
      </p:sp>
      <p:sp>
        <p:nvSpPr>
          <p:cNvPr id="10" name="TextBox 38">
            <a:extLst>
              <a:ext uri="{FF2B5EF4-FFF2-40B4-BE49-F238E27FC236}">
                <a16:creationId xmlns:a16="http://schemas.microsoft.com/office/drawing/2014/main" id="{CDB9D90A-AF88-194B-AFDC-23A07244EC91}"/>
              </a:ext>
            </a:extLst>
          </p:cNvPr>
          <p:cNvSpPr txBox="1"/>
          <p:nvPr/>
        </p:nvSpPr>
        <p:spPr>
          <a:xfrm>
            <a:off x="5528328" y="1874547"/>
            <a:ext cx="1421855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Granzyme 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2BAAD26-4E15-C044-A13A-9BCBB6FEFD06}"/>
              </a:ext>
            </a:extLst>
          </p:cNvPr>
          <p:cNvSpPr txBox="1"/>
          <p:nvPr/>
        </p:nvSpPr>
        <p:spPr>
          <a:xfrm>
            <a:off x="-38695" y="317892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A.</a:t>
            </a:r>
            <a:endParaRPr lang="en-US" sz="1766" b="1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E1C2CD4-5B17-754C-9CDD-FD0D414AB90D}"/>
              </a:ext>
            </a:extLst>
          </p:cNvPr>
          <p:cNvSpPr txBox="1"/>
          <p:nvPr/>
        </p:nvSpPr>
        <p:spPr>
          <a:xfrm>
            <a:off x="3617996" y="232365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C.</a:t>
            </a:r>
            <a:endParaRPr lang="en-US" sz="1766" b="1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CE9AAA3-661E-7A4B-ADA6-3DB4EB1B0370}"/>
              </a:ext>
            </a:extLst>
          </p:cNvPr>
          <p:cNvSpPr txBox="1"/>
          <p:nvPr/>
        </p:nvSpPr>
        <p:spPr>
          <a:xfrm>
            <a:off x="1770199" y="284659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B.</a:t>
            </a:r>
            <a:endParaRPr lang="en-US" sz="1766" b="1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DF0A0E-D23D-C84A-92E6-4AC43B659462}"/>
              </a:ext>
            </a:extLst>
          </p:cNvPr>
          <p:cNvSpPr txBox="1"/>
          <p:nvPr/>
        </p:nvSpPr>
        <p:spPr>
          <a:xfrm>
            <a:off x="5270795" y="207358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D.</a:t>
            </a:r>
            <a:endParaRPr lang="en-US" sz="1766" b="1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601E92-417C-8549-84AB-81BA19D18DA0}"/>
              </a:ext>
            </a:extLst>
          </p:cNvPr>
          <p:cNvSpPr txBox="1"/>
          <p:nvPr/>
        </p:nvSpPr>
        <p:spPr>
          <a:xfrm>
            <a:off x="-32752" y="1877874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E.</a:t>
            </a:r>
            <a:endParaRPr lang="en-US" sz="1766" b="1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1861DEE-C92E-0B40-96BA-F14E164CE560}"/>
              </a:ext>
            </a:extLst>
          </p:cNvPr>
          <p:cNvSpPr txBox="1"/>
          <p:nvPr/>
        </p:nvSpPr>
        <p:spPr>
          <a:xfrm>
            <a:off x="1799374" y="1836951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F.</a:t>
            </a:r>
            <a:endParaRPr lang="en-US" sz="1766" b="1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D29EFB4-557F-0A42-AED9-C70D7568852F}"/>
              </a:ext>
            </a:extLst>
          </p:cNvPr>
          <p:cNvSpPr txBox="1"/>
          <p:nvPr/>
        </p:nvSpPr>
        <p:spPr>
          <a:xfrm>
            <a:off x="3657600" y="1836951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G.</a:t>
            </a:r>
            <a:endParaRPr lang="en-US" sz="1766" b="1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7266B6B-7C71-6A49-9C88-F2260E581FC3}"/>
              </a:ext>
            </a:extLst>
          </p:cNvPr>
          <p:cNvSpPr txBox="1"/>
          <p:nvPr/>
        </p:nvSpPr>
        <p:spPr>
          <a:xfrm>
            <a:off x="5319567" y="1816514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>
                <a:ea typeface="Calibri"/>
                <a:cs typeface="Calibri"/>
              </a:rPr>
              <a:t>H.</a:t>
            </a:r>
            <a:endParaRPr lang="en-US" sz="1766" b="1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15A8D6D-2332-F94E-9E0F-E2293922E967}"/>
              </a:ext>
            </a:extLst>
          </p:cNvPr>
          <p:cNvSpPr txBox="1"/>
          <p:nvPr/>
        </p:nvSpPr>
        <p:spPr>
          <a:xfrm>
            <a:off x="0" y="3392110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66" b="1" dirty="0">
                <a:ea typeface="Calibri"/>
                <a:cs typeface="Calibri"/>
              </a:rPr>
              <a:t>I.</a:t>
            </a:r>
            <a:endParaRPr lang="en-US" sz="1766" b="1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A25782D9-A7AD-F340-A0D5-196D0DF165D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4164" t="17976" r="-49" b="60426"/>
          <a:stretch>
            <a:fillRect/>
          </a:stretch>
        </p:blipFill>
        <p:spPr>
          <a:xfrm>
            <a:off x="3582365" y="5116122"/>
            <a:ext cx="1127244" cy="59041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DD6EAF4-7F79-1849-B188-E1F2686EACB8}"/>
              </a:ext>
            </a:extLst>
          </p:cNvPr>
          <p:cNvSpPr txBox="1"/>
          <p:nvPr/>
        </p:nvSpPr>
        <p:spPr>
          <a:xfrm>
            <a:off x="1838684" y="3383468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50" b="1" dirty="0">
                <a:ea typeface="Calibri"/>
                <a:cs typeface="Calibri"/>
              </a:rPr>
              <a:t>J.</a:t>
            </a:r>
            <a:endParaRPr lang="en-US" sz="1750" b="1" dirty="0"/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FFB91C73-3D35-1441-BD0F-D9B251D93602}"/>
              </a:ext>
            </a:extLst>
          </p:cNvPr>
          <p:cNvGrpSpPr/>
          <p:nvPr/>
        </p:nvGrpSpPr>
        <p:grpSpPr>
          <a:xfrm>
            <a:off x="3795028" y="292419"/>
            <a:ext cx="1415938" cy="1433810"/>
            <a:chOff x="2008136" y="451086"/>
            <a:chExt cx="1415938" cy="1433810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E0229DA-BBB7-2C4A-969F-10A8562FBEDD}"/>
                </a:ext>
              </a:extLst>
            </p:cNvPr>
            <p:cNvSpPr txBox="1"/>
            <p:nvPr/>
          </p:nvSpPr>
          <p:spPr>
            <a:xfrm>
              <a:off x="2371143" y="451086"/>
              <a:ext cx="1029180" cy="246221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000" b="1" i="1" u="sng"/>
                <a:t>CD107a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52506643-C4D0-A14B-A3B2-FD8BBB68F1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-26" t="15041" r="33715" b="110"/>
            <a:stretch>
              <a:fillRect/>
            </a:stretch>
          </p:blipFill>
          <p:spPr>
            <a:xfrm>
              <a:off x="2008136" y="807258"/>
              <a:ext cx="1415938" cy="1077638"/>
            </a:xfrm>
            <a:prstGeom prst="rect">
              <a:avLst/>
            </a:prstGeom>
          </p:spPr>
        </p:pic>
      </p:grpSp>
      <p:pic>
        <p:nvPicPr>
          <p:cNvPr id="28" name="Picture 27">
            <a:extLst>
              <a:ext uri="{FF2B5EF4-FFF2-40B4-BE49-F238E27FC236}">
                <a16:creationId xmlns:a16="http://schemas.microsoft.com/office/drawing/2014/main" id="{1A46AD6B-5F1B-2F43-B2A5-94224BC9142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-26" t="15114" r="33854" b="107"/>
          <a:stretch>
            <a:fillRect/>
          </a:stretch>
        </p:blipFill>
        <p:spPr>
          <a:xfrm>
            <a:off x="233520" y="2200134"/>
            <a:ext cx="1416199" cy="110993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35B401CC-18B2-EB49-9749-FFEC204DA82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-26" t="14265" r="33024" b="110"/>
          <a:stretch>
            <a:fillRect/>
          </a:stretch>
        </p:blipFill>
        <p:spPr>
          <a:xfrm>
            <a:off x="2025317" y="2223173"/>
            <a:ext cx="1414952" cy="1077763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8EA4A3B0-CC6C-084B-993A-B49F51B7095A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-26" t="15592" r="32991" b="110"/>
          <a:stretch>
            <a:fillRect/>
          </a:stretch>
        </p:blipFill>
        <p:spPr>
          <a:xfrm>
            <a:off x="3808287" y="2212856"/>
            <a:ext cx="1413266" cy="1060761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F2974E6-7964-CA4F-87B2-A417305887F5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-26" t="15262" r="32936" b="-220"/>
          <a:stretch>
            <a:fillRect/>
          </a:stretch>
        </p:blipFill>
        <p:spPr>
          <a:xfrm>
            <a:off x="5420422" y="2206133"/>
            <a:ext cx="1416122" cy="106748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D3F85D20-72D8-C64A-840C-4E501A76C0D2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-26" t="15307" r="32991" b="-12"/>
          <a:stretch>
            <a:fillRect/>
          </a:stretch>
        </p:blipFill>
        <p:spPr>
          <a:xfrm>
            <a:off x="186643" y="3837425"/>
            <a:ext cx="1413266" cy="1068064"/>
          </a:xfrm>
          <a:prstGeom prst="rect">
            <a:avLst/>
          </a:prstGeom>
        </p:spPr>
      </p:pic>
      <p:grpSp>
        <p:nvGrpSpPr>
          <p:cNvPr id="27" name="Group 26">
            <a:extLst>
              <a:ext uri="{FF2B5EF4-FFF2-40B4-BE49-F238E27FC236}">
                <a16:creationId xmlns:a16="http://schemas.microsoft.com/office/drawing/2014/main" id="{E2E79E6F-F222-AB4D-9EB3-95007B5625DE}"/>
              </a:ext>
            </a:extLst>
          </p:cNvPr>
          <p:cNvGrpSpPr/>
          <p:nvPr/>
        </p:nvGrpSpPr>
        <p:grpSpPr>
          <a:xfrm>
            <a:off x="5420422" y="321676"/>
            <a:ext cx="1741286" cy="1428395"/>
            <a:chOff x="1958253" y="3628193"/>
            <a:chExt cx="1741286" cy="1428395"/>
          </a:xfrm>
        </p:grpSpPr>
        <p:sp>
          <p:nvSpPr>
            <p:cNvPr id="22" name="TextBox 4">
              <a:extLst>
                <a:ext uri="{FF2B5EF4-FFF2-40B4-BE49-F238E27FC236}">
                  <a16:creationId xmlns:a16="http://schemas.microsoft.com/office/drawing/2014/main" id="{E65BBE83-E0CA-184A-A273-73295AC56891}"/>
                </a:ext>
              </a:extLst>
            </p:cNvPr>
            <p:cNvSpPr txBox="1"/>
            <p:nvPr/>
          </p:nvSpPr>
          <p:spPr>
            <a:xfrm>
              <a:off x="2059786" y="3628193"/>
              <a:ext cx="1639753" cy="244460"/>
            </a:xfrm>
            <a:prstGeom prst="rect">
              <a:avLst/>
            </a:prstGeom>
            <a:noFill/>
          </p:spPr>
          <p:txBody>
            <a:bodyPr wrap="square" lIns="89696" tIns="44848" rIns="89696" bIns="44848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000" b="1" i="1" u="sng" dirty="0" err="1">
                  <a:ea typeface="Calibri"/>
                  <a:cs typeface="Calibri"/>
                </a:rPr>
                <a:t>Eomes</a:t>
              </a:r>
              <a:endParaRPr lang="en-US" sz="1000" b="1" dirty="0" err="1">
                <a:ea typeface="+mn-lt"/>
                <a:cs typeface="+mn-lt"/>
              </a:endParaRP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37E1C7D4-E182-7244-80F3-0A8C2969166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t="14650" r="32873" b="364"/>
            <a:stretch>
              <a:fillRect/>
            </a:stretch>
          </p:blipFill>
          <p:spPr>
            <a:xfrm>
              <a:off x="1958253" y="3988244"/>
              <a:ext cx="1414607" cy="1068344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D29BE0F7-AAD7-F34B-B1BE-7AD40B9B7C58}"/>
              </a:ext>
            </a:extLst>
          </p:cNvPr>
          <p:cNvSpPr txBox="1"/>
          <p:nvPr/>
        </p:nvSpPr>
        <p:spPr>
          <a:xfrm>
            <a:off x="2573299" y="3496263"/>
            <a:ext cx="544012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TIGI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3880BCD-ABC3-CD45-80B9-7A118BD089E0}"/>
              </a:ext>
            </a:extLst>
          </p:cNvPr>
          <p:cNvSpPr txBox="1"/>
          <p:nvPr/>
        </p:nvSpPr>
        <p:spPr>
          <a:xfrm>
            <a:off x="2638353" y="5165106"/>
            <a:ext cx="544012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TIM-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980D3AC-7EF4-B24D-8244-1AC9F676156F}"/>
              </a:ext>
            </a:extLst>
          </p:cNvPr>
          <p:cNvSpPr txBox="1"/>
          <p:nvPr/>
        </p:nvSpPr>
        <p:spPr>
          <a:xfrm>
            <a:off x="4258230" y="3442261"/>
            <a:ext cx="899936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PD1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1E9613C-1928-B949-947D-C965D3175C15}"/>
              </a:ext>
            </a:extLst>
          </p:cNvPr>
          <p:cNvSpPr txBox="1"/>
          <p:nvPr/>
        </p:nvSpPr>
        <p:spPr>
          <a:xfrm>
            <a:off x="847238" y="5227749"/>
            <a:ext cx="603855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US" sz="1000" b="1" i="1" u="sng" dirty="0"/>
              <a:t>TCF-1</a:t>
            </a:r>
          </a:p>
        </p:txBody>
      </p:sp>
      <p:sp>
        <p:nvSpPr>
          <p:cNvPr id="39" name="TextBox 27">
            <a:extLst>
              <a:ext uri="{FF2B5EF4-FFF2-40B4-BE49-F238E27FC236}">
                <a16:creationId xmlns:a16="http://schemas.microsoft.com/office/drawing/2014/main" id="{D66BA062-613A-FE4E-B18E-F8954A4B78B5}"/>
              </a:ext>
            </a:extLst>
          </p:cNvPr>
          <p:cNvSpPr txBox="1"/>
          <p:nvPr/>
        </p:nvSpPr>
        <p:spPr>
          <a:xfrm>
            <a:off x="6239255" y="3437932"/>
            <a:ext cx="560143" cy="24622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i="1" u="sng" dirty="0"/>
              <a:t>CTLA4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95B0A705-CCF7-6746-ABF8-B89668F97EC4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-26" t="15303" r="34301" b="-43"/>
          <a:stretch>
            <a:fillRect/>
          </a:stretch>
        </p:blipFill>
        <p:spPr>
          <a:xfrm>
            <a:off x="1974074" y="3797170"/>
            <a:ext cx="1471249" cy="1150392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6FFCB9A2-737A-8749-9F39-6DC70948B6F7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40" t="15660" r="34297" b="107"/>
          <a:stretch>
            <a:fillRect/>
          </a:stretch>
        </p:blipFill>
        <p:spPr>
          <a:xfrm>
            <a:off x="3848096" y="3777086"/>
            <a:ext cx="1471471" cy="1154983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33BA36A6-766C-6748-BF00-10068F056292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-26" t="15174" r="34122" b="483"/>
          <a:stretch>
            <a:fillRect/>
          </a:stretch>
        </p:blipFill>
        <p:spPr>
          <a:xfrm>
            <a:off x="5687932" y="3743414"/>
            <a:ext cx="1473776" cy="1151579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CCD3D50A-493B-B34F-A0AA-A341A3BB7898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-26" t="15603" r="33991" b="483"/>
          <a:stretch>
            <a:fillRect/>
          </a:stretch>
        </p:blipFill>
        <p:spPr>
          <a:xfrm>
            <a:off x="233888" y="5512460"/>
            <a:ext cx="1473779" cy="1144561"/>
          </a:xfrm>
          <a:prstGeom prst="rect">
            <a:avLst/>
          </a:prstGeom>
        </p:spPr>
      </p:pic>
      <p:pic>
        <p:nvPicPr>
          <p:cNvPr id="45" name="Picture 44" descr="A diagram of a number of dots&#10;&#10;AI-generated content may be incorrect.">
            <a:extLst>
              <a:ext uri="{FF2B5EF4-FFF2-40B4-BE49-F238E27FC236}">
                <a16:creationId xmlns:a16="http://schemas.microsoft.com/office/drawing/2014/main" id="{ADA8FAF4-0776-AF4A-878C-956214338E69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-26" t="15736" r="33154" b="966"/>
          <a:stretch>
            <a:fillRect/>
          </a:stretch>
        </p:blipFill>
        <p:spPr>
          <a:xfrm>
            <a:off x="2033012" y="5512460"/>
            <a:ext cx="1472831" cy="1120895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00848FE3-3797-9745-B443-CB0AE4812285}"/>
              </a:ext>
            </a:extLst>
          </p:cNvPr>
          <p:cNvSpPr txBox="1"/>
          <p:nvPr/>
        </p:nvSpPr>
        <p:spPr>
          <a:xfrm>
            <a:off x="3611415" y="3349944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50" b="1" dirty="0">
                <a:ea typeface="Calibri"/>
                <a:cs typeface="Calibri"/>
              </a:rPr>
              <a:t>K.</a:t>
            </a:r>
            <a:endParaRPr lang="en-US" sz="1750" b="1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6F852AF-4846-544C-B6A5-85BC66801731}"/>
              </a:ext>
            </a:extLst>
          </p:cNvPr>
          <p:cNvSpPr txBox="1"/>
          <p:nvPr/>
        </p:nvSpPr>
        <p:spPr>
          <a:xfrm>
            <a:off x="5383679" y="3342484"/>
            <a:ext cx="417523" cy="362288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50" b="1" dirty="0">
                <a:ea typeface="Calibri"/>
                <a:cs typeface="Calibri"/>
              </a:rPr>
              <a:t>L.</a:t>
            </a:r>
            <a:endParaRPr lang="en-US" sz="1750" b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89BBFC2-26A8-F345-BCFB-E4B0EDB4B0AB}"/>
              </a:ext>
            </a:extLst>
          </p:cNvPr>
          <p:cNvSpPr txBox="1"/>
          <p:nvPr/>
        </p:nvSpPr>
        <p:spPr>
          <a:xfrm>
            <a:off x="-22119" y="5086840"/>
            <a:ext cx="544012" cy="35987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50" b="1" dirty="0">
                <a:ea typeface="Calibri"/>
                <a:cs typeface="Calibri"/>
              </a:rPr>
              <a:t>M.</a:t>
            </a:r>
            <a:endParaRPr lang="en-US" sz="1750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3E2C043-4599-364E-8D68-BBA6990E897C}"/>
              </a:ext>
            </a:extLst>
          </p:cNvPr>
          <p:cNvSpPr txBox="1"/>
          <p:nvPr/>
        </p:nvSpPr>
        <p:spPr>
          <a:xfrm>
            <a:off x="1737474" y="5060245"/>
            <a:ext cx="544012" cy="359876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89696" tIns="44848" rIns="89696" bIns="44848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750" b="1" dirty="0">
                <a:ea typeface="Calibri"/>
                <a:cs typeface="Calibri"/>
              </a:rPr>
              <a:t>N.</a:t>
            </a:r>
            <a:endParaRPr lang="en-US" sz="1750" b="1" dirty="0"/>
          </a:p>
        </p:txBody>
      </p:sp>
      <p:pic>
        <p:nvPicPr>
          <p:cNvPr id="52" name="Picture 51">
            <a:extLst>
              <a:ext uri="{FF2B5EF4-FFF2-40B4-BE49-F238E27FC236}">
                <a16:creationId xmlns:a16="http://schemas.microsoft.com/office/drawing/2014/main" id="{464CFCCC-4FED-ED4F-8383-FD5D0662986C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0845" r="33580"/>
          <a:stretch/>
        </p:blipFill>
        <p:spPr>
          <a:xfrm>
            <a:off x="198850" y="601198"/>
            <a:ext cx="1433022" cy="1115584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48D568F5-BE04-264F-877B-1C411C7DC36C}"/>
              </a:ext>
            </a:extLst>
          </p:cNvPr>
          <p:cNvGrpSpPr/>
          <p:nvPr/>
        </p:nvGrpSpPr>
        <p:grpSpPr>
          <a:xfrm>
            <a:off x="2059296" y="305786"/>
            <a:ext cx="1413268" cy="1435102"/>
            <a:chOff x="3812251" y="423574"/>
            <a:chExt cx="1413268" cy="1435102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647210A-641E-BB49-B64B-A0E10A3BAA44}"/>
                </a:ext>
              </a:extLst>
            </p:cNvPr>
            <p:cNvSpPr txBox="1"/>
            <p:nvPr/>
          </p:nvSpPr>
          <p:spPr>
            <a:xfrm>
              <a:off x="4149542" y="423574"/>
              <a:ext cx="856607" cy="4001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000" b="1" i="1" u="sng"/>
                <a:t>Ki67</a:t>
              </a:r>
            </a:p>
            <a:p>
              <a:pPr algn="r"/>
              <a:endParaRPr lang="en-US" sz="1000" b="1" i="1" u="sng"/>
            </a:p>
          </p:txBody>
        </p:sp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87396E44-385A-7F4E-9679-D2C7974BE3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/>
            <a:srcRect t="14311" r="29901"/>
            <a:stretch/>
          </p:blipFill>
          <p:spPr>
            <a:xfrm>
              <a:off x="3812251" y="603550"/>
              <a:ext cx="1413268" cy="1255126"/>
            </a:xfrm>
            <a:prstGeom prst="rect">
              <a:avLst/>
            </a:prstGeom>
          </p:spPr>
        </p:pic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3FCBBFC5-6D7C-E341-A84B-E2170C884F54}"/>
              </a:ext>
            </a:extLst>
          </p:cNvPr>
          <p:cNvSpPr txBox="1"/>
          <p:nvPr/>
        </p:nvSpPr>
        <p:spPr>
          <a:xfrm>
            <a:off x="46464" y="6798453"/>
            <a:ext cx="7183827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2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ctivation and exhaustion markers on CD8</a:t>
            </a:r>
            <a:r>
              <a:rPr lang="en-US" sz="1200" b="1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subsets present in responders and non-responders.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-N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and sgCD73 tumors that were untreated or treated with anti-CTLA4 were analyzed by flow cytometry for the indicated immune cell populations after gating on CD45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cells followed by CD3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-cells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D44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CD44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Ki67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Ki67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D107a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CD107a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omes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omes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Perforin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Perforin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F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IFN-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γ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IFN-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γ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G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Granzyme A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Granzyme A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Granzyme B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Granzyme B.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(I)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NF-α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s expressing TNF-α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J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IGIT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TIGIT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K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PD1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PD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L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CTLA4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CTLA4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CF-1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TCF-1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N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im-3, % of CD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expressing Tim-3. Data represent pooled values from 3 independent experiments where n= 2-4 for each group. Bar graph data represent SEM, two-way ANOVA with Tukey’s multiple comparison test.</a:t>
            </a:r>
            <a:endParaRPr lang="en-US" sz="12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504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319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26:34Z</dcterms:modified>
</cp:coreProperties>
</file>